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4788" y="1162050"/>
            <a:ext cx="40608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atmap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how similar information, except that these show the expression in both humanized and non-humanized sampl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22A78B4-7EA9-4D98-9F86-E18775CE8DC1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457962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374784" y="608222"/>
            <a:ext cx="33088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9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315015" y="1776245"/>
            <a:ext cx="9683826" cy="4681704"/>
            <a:chOff x="443205" y="1776245"/>
            <a:chExt cx="9683826" cy="4681704"/>
          </a:xfrm>
        </p:grpSpPr>
        <p:grpSp>
          <p:nvGrpSpPr>
            <p:cNvPr id="16" name="Group 15"/>
            <p:cNvGrpSpPr/>
            <p:nvPr/>
          </p:nvGrpSpPr>
          <p:grpSpPr>
            <a:xfrm>
              <a:off x="443205" y="1776245"/>
              <a:ext cx="9683826" cy="4681704"/>
              <a:chOff x="443205" y="1776245"/>
              <a:chExt cx="9683826" cy="4681704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443205" y="1776245"/>
                <a:ext cx="9683826" cy="4681704"/>
                <a:chOff x="443205" y="1776245"/>
                <a:chExt cx="9683826" cy="4681704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443205" y="1776245"/>
                  <a:ext cx="9683826" cy="4681704"/>
                  <a:chOff x="537211" y="1776245"/>
                  <a:chExt cx="9683826" cy="4681704"/>
                </a:xfrm>
              </p:grpSpPr>
              <p:sp>
                <p:nvSpPr>
                  <p:cNvPr id="2" name="TextBox 1"/>
                  <p:cNvSpPr txBox="1"/>
                  <p:nvPr/>
                </p:nvSpPr>
                <p:spPr>
                  <a:xfrm>
                    <a:off x="1005840" y="1776245"/>
                    <a:ext cx="4000499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400" b="1" i="0" u="none" strike="noStrike" kern="1200" cap="none" spc="0" normalizeH="0" baseline="0" noProof="0" dirty="0" err="1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HuNBSGW</a:t>
                    </a:r>
                    <a:r>
                      <a:rPr kumimoji="0" lang="en-US" sz="14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 Brain</a:t>
                    </a:r>
                  </a:p>
                </p:txBody>
              </p:sp>
              <p:sp>
                <p:nvSpPr>
                  <p:cNvPr id="6" name="TextBox 5"/>
                  <p:cNvSpPr txBox="1"/>
                  <p:nvPr/>
                </p:nvSpPr>
                <p:spPr>
                  <a:xfrm>
                    <a:off x="5006338" y="1780012"/>
                    <a:ext cx="4069081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ctr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4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NBSGW </a:t>
                    </a:r>
                    <a:r>
                      <a:rPr kumimoji="0" lang="en-US" sz="14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Brain</a:t>
                    </a:r>
                  </a:p>
                </p:txBody>
              </p:sp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0398" r="5656" b="5583"/>
                  <a:stretch/>
                </p:blipFill>
                <p:spPr>
                  <a:xfrm>
                    <a:off x="537211" y="2028496"/>
                    <a:ext cx="8842198" cy="4429453"/>
                  </a:xfrm>
                  <a:prstGeom prst="rect">
                    <a:avLst/>
                  </a:prstGeom>
                </p:spPr>
              </p:pic>
              <p:sp>
                <p:nvSpPr>
                  <p:cNvPr id="3" name="TextBox 2"/>
                  <p:cNvSpPr txBox="1"/>
                  <p:nvPr/>
                </p:nvSpPr>
                <p:spPr>
                  <a:xfrm>
                    <a:off x="9258914" y="4490276"/>
                    <a:ext cx="962123" cy="36420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20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 err="1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HuNBSGW</a:t>
                    </a:r>
                    <a:r>
                      <a:rPr kumimoji="0" lang="en-US" sz="8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 brain</a:t>
                    </a:r>
                  </a:p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20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800" b="0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NBSGW brain</a:t>
                    </a:r>
                    <a:endParaRPr kumimoji="0" 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1" name="Rectangle 10"/>
                <p:cNvSpPr/>
                <p:nvPr/>
              </p:nvSpPr>
              <p:spPr>
                <a:xfrm>
                  <a:off x="9125146" y="3340231"/>
                  <a:ext cx="443060" cy="1822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  <p:sp>
              <p:nvSpPr>
                <p:cNvPr id="12" name="Rectangle 11"/>
                <p:cNvSpPr/>
                <p:nvPr/>
              </p:nvSpPr>
              <p:spPr>
                <a:xfrm>
                  <a:off x="9125146" y="4353612"/>
                  <a:ext cx="443060" cy="18225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14" name="TextBox 13"/>
              <p:cNvSpPr txBox="1"/>
              <p:nvPr/>
            </p:nvSpPr>
            <p:spPr>
              <a:xfrm>
                <a:off x="9077820" y="4345031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Identity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9027143" y="3309656"/>
                <a:ext cx="75533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xpression</a:t>
                </a:r>
                <a:endParaRPr kumimoji="0" lang="en-US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TextBox 16"/>
            <p:cNvSpPr txBox="1"/>
            <p:nvPr/>
          </p:nvSpPr>
          <p:spPr>
            <a:xfrm>
              <a:off x="9194629" y="3448006"/>
              <a:ext cx="287258" cy="836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1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1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-2</a:t>
              </a:r>
              <a:endPara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0194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40</Words>
  <Application>Microsoft Office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22</cp:revision>
  <dcterms:created xsi:type="dcterms:W3CDTF">2024-11-19T17:14:58Z</dcterms:created>
  <dcterms:modified xsi:type="dcterms:W3CDTF">2024-11-19T17:48:24Z</dcterms:modified>
</cp:coreProperties>
</file>